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7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8064A-1525-49F0-8AAC-EED40F3649A2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6BF-68D6-4E17-AA9F-E9B49033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091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8064A-1525-49F0-8AAC-EED40F3649A2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6BF-68D6-4E17-AA9F-E9B49033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98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8064A-1525-49F0-8AAC-EED40F3649A2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6BF-68D6-4E17-AA9F-E9B49033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186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8064A-1525-49F0-8AAC-EED40F3649A2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6BF-68D6-4E17-AA9F-E9B49033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070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8064A-1525-49F0-8AAC-EED40F3649A2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6BF-68D6-4E17-AA9F-E9B49033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773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8064A-1525-49F0-8AAC-EED40F3649A2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6BF-68D6-4E17-AA9F-E9B49033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712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8064A-1525-49F0-8AAC-EED40F3649A2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6BF-68D6-4E17-AA9F-E9B49033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659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8064A-1525-49F0-8AAC-EED40F3649A2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6BF-68D6-4E17-AA9F-E9B49033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609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8064A-1525-49F0-8AAC-EED40F3649A2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6BF-68D6-4E17-AA9F-E9B49033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4500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8064A-1525-49F0-8AAC-EED40F3649A2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6BF-68D6-4E17-AA9F-E9B49033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698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8064A-1525-49F0-8AAC-EED40F3649A2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6BF-68D6-4E17-AA9F-E9B49033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576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F8064A-1525-49F0-8AAC-EED40F3649A2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1036BF-68D6-4E17-AA9F-E9B49033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793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642" y="372718"/>
            <a:ext cx="7684830" cy="611631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8282398" y="1275347"/>
            <a:ext cx="3452403" cy="40934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1. </a:t>
            </a:r>
            <a:r>
              <a:rPr lang="en-US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) </a:t>
            </a:r>
            <a:r>
              <a:rPr lang="en-US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enetic environment of 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la</a:t>
            </a:r>
            <a:r>
              <a:rPr lang="en-US" sz="10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XA-48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la</a:t>
            </a:r>
            <a:r>
              <a:rPr lang="en-US" sz="10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DM-1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n 14 </a:t>
            </a:r>
            <a:r>
              <a:rPr lang="en-US" sz="10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listin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resistant OXA-48-producing 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K. </a:t>
            </a:r>
            <a:r>
              <a:rPr lang="en-US" sz="1000" i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neumoniae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trains. 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la</a:t>
            </a:r>
            <a:r>
              <a:rPr lang="en-US" sz="10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XA-48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was identified in all strains except for P26. </a:t>
            </a:r>
            <a:r>
              <a:rPr lang="en-US" sz="1000" i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ysR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la</a:t>
            </a:r>
            <a:r>
              <a:rPr lang="en-US" sz="10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XA-48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mplex was found in all strains. No transposase element was detected surrounding </a:t>
            </a:r>
            <a:r>
              <a:rPr lang="en-US" sz="1000" i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ysR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la</a:t>
            </a:r>
            <a:r>
              <a:rPr lang="en-US" sz="10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XA-48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mplex in P6, P7, P40, P42 and P43. Two 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la</a:t>
            </a:r>
            <a:r>
              <a:rPr lang="en-US" sz="10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XA-48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ith different genetic arrangement were found on P32 plasmid. In P36, P37, P38 and P44; </a:t>
            </a:r>
            <a:r>
              <a:rPr lang="en-US" sz="1000" i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ysR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la</a:t>
            </a:r>
            <a:r>
              <a:rPr lang="en-US" sz="10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XA-48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mplex was flanked upstream by DDE, IS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91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IS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nd IS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10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family transposase genes, respectively</a:t>
            </a:r>
            <a:r>
              <a:rPr lang="en-US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0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)</a:t>
            </a:r>
            <a:r>
              <a:rPr lang="en-US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la</a:t>
            </a:r>
            <a:r>
              <a:rPr lang="en-US" sz="10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DM-1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as detected only in P6 and P26 strains. 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la</a:t>
            </a:r>
            <a:r>
              <a:rPr lang="en-US" sz="10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DM-1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as flanked </a:t>
            </a:r>
            <a:r>
              <a:rPr lang="en-US" sz="10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upsteram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by </a:t>
            </a:r>
            <a:r>
              <a:rPr lang="en-US" sz="10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leomycin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binding protein and </a:t>
            </a:r>
            <a:r>
              <a:rPr lang="en-US" sz="1000" i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rpF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genes and downstream by IS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91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family transposase.</a:t>
            </a:r>
            <a:endParaRPr lang="en-US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80610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3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badmasti2008@outlook.com</dc:creator>
  <cp:lastModifiedBy>Rajalakshmi</cp:lastModifiedBy>
  <cp:revision>2</cp:revision>
  <dcterms:created xsi:type="dcterms:W3CDTF">2021-09-12T18:10:47Z</dcterms:created>
  <dcterms:modified xsi:type="dcterms:W3CDTF">2021-10-15T06:59:16Z</dcterms:modified>
</cp:coreProperties>
</file>